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19925" cy="93059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98ADA-7242-4F79-84C1-7EAAD38C0C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B3510-9FB1-42FE-8CBE-C802A0CBB9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A2D4E2-C5E7-49DC-B6FE-F99474E261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327E1-53BC-49EA-B00B-F69889EB2E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C2BD5-0224-403E-84CD-906B325C2F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B2C27-53ED-497C-8021-F825EF4D67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2C558-7718-4405-821F-48606AAA2B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8AC25-052B-4A70-AF0A-6D03EC9A1D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E61B76-88C8-4C1E-894B-B58A0A8334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3DE6E-3D22-4323-B491-D0CC4571F9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BD1AB1-ED4C-41EC-8EF3-2FECE5178A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E3534-F370-4B41-A178-C2433AA54B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79C7B4-3807-4137-9401-4493AB30899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3"/>
          <p:cNvGraphicFramePr/>
          <p:nvPr/>
        </p:nvGraphicFramePr>
        <p:xfrm>
          <a:off x="1143000" y="228600"/>
          <a:ext cx="6705720" cy="3922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43000" y="228600"/>
                    <a:ext cx="6705720" cy="3922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Box 5"/>
          <p:cNvSpPr/>
          <p:nvPr/>
        </p:nvSpPr>
        <p:spPr>
          <a:xfrm>
            <a:off x="1463760" y="4048200"/>
            <a:ext cx="63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train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2014560" y="409572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26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1"/>
          <p:cNvSpPr/>
          <p:nvPr/>
        </p:nvSpPr>
        <p:spPr>
          <a:xfrm>
            <a:off x="2346480" y="4095720"/>
            <a:ext cx="685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CTC1317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2"/>
          <p:cNvSpPr/>
          <p:nvPr/>
        </p:nvSpPr>
        <p:spPr>
          <a:xfrm>
            <a:off x="2897280" y="4095720"/>
            <a:ext cx="463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26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3"/>
          <p:cNvSpPr/>
          <p:nvPr/>
        </p:nvSpPr>
        <p:spPr>
          <a:xfrm>
            <a:off x="3146400" y="4095720"/>
            <a:ext cx="685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CTC1317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4"/>
          <p:cNvSpPr/>
          <p:nvPr/>
        </p:nvSpPr>
        <p:spPr>
          <a:xfrm>
            <a:off x="3665520" y="4095720"/>
            <a:ext cx="48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SHR 367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5"/>
          <p:cNvSpPr/>
          <p:nvPr/>
        </p:nvSpPr>
        <p:spPr>
          <a:xfrm>
            <a:off x="4091040" y="4095720"/>
            <a:ext cx="48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SHR 9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6"/>
          <p:cNvSpPr/>
          <p:nvPr/>
        </p:nvSpPr>
        <p:spPr>
          <a:xfrm>
            <a:off x="4479840" y="4095720"/>
            <a:ext cx="54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SHR  840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7"/>
          <p:cNvSpPr/>
          <p:nvPr/>
        </p:nvSpPr>
        <p:spPr>
          <a:xfrm>
            <a:off x="4807080" y="4095720"/>
            <a:ext cx="48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SHR 454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8"/>
          <p:cNvSpPr/>
          <p:nvPr/>
        </p:nvSpPr>
        <p:spPr>
          <a:xfrm>
            <a:off x="5164200" y="4095720"/>
            <a:ext cx="53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SHR  1950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9"/>
          <p:cNvSpPr/>
          <p:nvPr/>
        </p:nvSpPr>
        <p:spPr>
          <a:xfrm>
            <a:off x="5570640" y="4095720"/>
            <a:ext cx="4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SMB 12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0"/>
          <p:cNvSpPr/>
          <p:nvPr/>
        </p:nvSpPr>
        <p:spPr>
          <a:xfrm>
            <a:off x="5979960" y="4095720"/>
            <a:ext cx="4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SHR  304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1"/>
          <p:cNvSpPr/>
          <p:nvPr/>
        </p:nvSpPr>
        <p:spPr>
          <a:xfrm>
            <a:off x="6408720" y="4095720"/>
            <a:ext cx="685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Arial"/>
              </a:rPr>
              <a:t>E. coli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HB10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2"/>
          <p:cNvSpPr/>
          <p:nvPr/>
        </p:nvSpPr>
        <p:spPr>
          <a:xfrm>
            <a:off x="824040" y="4343400"/>
            <a:ext cx="1218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O-antigen typ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3"/>
          <p:cNvSpPr/>
          <p:nvPr/>
        </p:nvSpPr>
        <p:spPr>
          <a:xfrm>
            <a:off x="1981080" y="4343400"/>
            <a:ext cx="5562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          A          A         B          B             B          B2     B2         B2      B2       Rough    N/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21T20:09:40Z</dcterms:created>
  <dc:creator>Apachai Tuanyok</dc:creator>
  <dc:description/>
  <dc:language>en-US</dc:language>
  <cp:lastModifiedBy>Apichai Tuanyok</cp:lastModifiedBy>
  <dcterms:modified xsi:type="dcterms:W3CDTF">2011-11-24T16:18:19Z</dcterms:modified>
  <cp:revision>15</cp:revision>
  <dc:subject/>
  <dc:title>Slide 1</dc:title>
</cp:coreProperties>
</file>